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64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76BD9-4B6B-419D-9BC3-E2098C61F2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876F01-0754-48CD-9490-C6158947E2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DDE5C-3F3C-49CD-8F2D-EABD09839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B5E6B7-0F0D-4CA1-8B94-B9A73EC1A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2779D-A607-4540-825C-E9D15775A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767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6FF7D-E522-411B-9DF7-880BCDAA6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271362-EFF1-4782-9E19-6D7E05303E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601ECA-84B5-444C-85D5-30AE64C1E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6C8CBE-ACA0-4556-A497-09331B0E2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BE45F-F21D-4C31-B42D-10925AFE4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635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0B7C74-AEC2-4F3D-BEB7-F6A2F47A6A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2A2EB1-260D-449F-B633-991EBB0D13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1D1E50-1CB2-4418-B866-9CB02A7EE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56B32F-F28B-466B-BE9F-D401D0467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BD4C3B-5773-4291-B233-4551053039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6988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0FE1C3-A4AB-42E3-99C3-E8949908A4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4DC63C-A93D-46E0-8026-1CB3BAB2C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AB3431-B2AE-4053-896B-0C7CF07B6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1BDC28-92F1-4D85-86E2-79E03C1E2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E53454-B586-4094-A1A2-90C1E732A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849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A1DF44-3F57-438C-9C77-5C534B5FD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1C1FC9-551D-45AA-9505-99A9E33500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7DE768-A5C6-45E7-82D9-060012920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ED0F5-5511-4E5C-818E-E726B4C52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479B69-EEA7-4768-8E6C-0CEA71EDF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214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6377C-B1E0-42E0-8976-43C3FA89B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5ED28B-FEBB-4A98-8D2F-95A526622E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1CA552-3352-4B45-8000-60F7F22806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2FFDE2-5B86-4575-B331-C680CB4C1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5A50E8-5CB8-4CD9-A39C-1AEEAC26B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E0FD18-5A9F-46C7-8A51-C2A21F174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6475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216789-7D92-483F-8C95-375A0DFDC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D41D77-EDC9-4BE7-85F0-5F04BE0437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245715-0138-4351-84D0-2052A5A501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1C05E6-90A3-4647-8834-8F1965B5AA3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02D42C-374A-4671-B8AB-128697A403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27B4672-F0D5-4D63-AE05-83781D695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26FF17-471A-450D-9B0C-E02947255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93C759-B913-4F05-AB90-5D97C36D9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4946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FD38EA-04ED-442D-9DC3-D36103221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0D1833-E1BD-44A6-AAB4-D9275B574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72A821-C74C-4614-A8E1-787B43BC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AABE15-3FB9-4618-B4DC-AFC56ACFC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1642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CC31C3-6256-48F4-8397-DD2DF7767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0E3507-BFC7-4616-96EF-2F026025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ABD3B48-B81D-434B-A8F5-F92A54643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141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411AAC-DCAA-45F3-991A-E7E06A3106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D99F6A-A771-44FE-A9D9-D384FC2336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75B53A-4642-4E92-BA57-8A0054A5DD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86CBEA-AC65-44AC-9756-F698C3C12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76D53C-86A6-4478-97A3-414E14EEE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027F27-4749-4304-9714-24093B311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7206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FF5CBD-4F33-440E-B5A0-B3FD037F2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FA07D3-84FB-46C4-8131-84A5C42232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3AA63E-D0FE-4F72-AA1C-2B4D7575EB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E668DE-4D82-4314-A119-8988793A6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95F2ED-7741-4E5C-BD54-124E75B45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0728E6-5E90-4F25-95F2-18D4AA609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019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3DB1B1-FF2D-453D-B680-28F902F26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D676A4-5DB2-4253-8327-7D6CBF9DC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00DACA-3F70-4E67-BEDF-2C70A689B8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708A1-4878-44AE-927F-80062EAF8259}" type="datetimeFigureOut">
              <a:rPr lang="en-GB" smtClean="0"/>
              <a:t>04/0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03C6C-6395-4B13-A87D-1E94C879DE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F2CC55-7EC6-438D-B775-F3A8B12A83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BA4B1-D799-4249-AADE-F0C8386A56F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1332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756BF1F0-D6E8-4072-8042-097472A5546A}"/>
              </a:ext>
            </a:extLst>
          </p:cNvPr>
          <p:cNvGrpSpPr/>
          <p:nvPr/>
        </p:nvGrpSpPr>
        <p:grpSpPr>
          <a:xfrm>
            <a:off x="3596187" y="2201957"/>
            <a:ext cx="4441384" cy="1227043"/>
            <a:chOff x="3891462" y="556189"/>
            <a:chExt cx="4441384" cy="1227043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6237BD5-D156-4C83-B2DD-911720D85D47}"/>
                </a:ext>
              </a:extLst>
            </p:cNvPr>
            <p:cNvGrpSpPr/>
            <p:nvPr/>
          </p:nvGrpSpPr>
          <p:grpSpPr>
            <a:xfrm>
              <a:off x="3961027" y="811232"/>
              <a:ext cx="4371819" cy="972000"/>
              <a:chOff x="3961027" y="208722"/>
              <a:chExt cx="4371819" cy="972000"/>
            </a:xfrm>
          </p:grpSpPr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035655D5-18D2-4495-B635-B0B7974A54DD}"/>
                  </a:ext>
                </a:extLst>
              </p:cNvPr>
              <p:cNvSpPr txBox="1"/>
              <p:nvPr/>
            </p:nvSpPr>
            <p:spPr>
              <a:xfrm>
                <a:off x="4087631" y="412775"/>
                <a:ext cx="769763" cy="7316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31" dirty="0">
                    <a:latin typeface="Arial Nova" panose="020B0504020202020204" pitchFamily="34" charset="0"/>
                    <a:cs typeface="Arial" panose="020B0604020202020204" pitchFamily="34" charset="0"/>
                  </a:rPr>
                  <a:t>“met1”</a:t>
                </a:r>
              </a:p>
              <a:p>
                <a:r>
                  <a:rPr lang="en-GB" sz="831" dirty="0">
                    <a:latin typeface="Arial Nova" panose="020B0504020202020204" pitchFamily="34" charset="0"/>
                    <a:cs typeface="Arial" panose="020B0604020202020204" pitchFamily="34" charset="0"/>
                  </a:rPr>
                  <a:t>#110</a:t>
                </a:r>
              </a:p>
              <a:p>
                <a:r>
                  <a:rPr lang="en-GB" sz="831" dirty="0">
                    <a:latin typeface="Arial Nova" panose="020B0504020202020204" pitchFamily="34" charset="0"/>
                    <a:cs typeface="Arial" panose="020B0604020202020204" pitchFamily="34" charset="0"/>
                  </a:rPr>
                  <a:t>Day 178</a:t>
                </a:r>
              </a:p>
              <a:p>
                <a:endParaRPr lang="en-GB" sz="831" dirty="0">
                  <a:latin typeface="Arial Nova" panose="020B0504020202020204" pitchFamily="34" charset="0"/>
                  <a:cs typeface="Arial" panose="020B0604020202020204" pitchFamily="34" charset="0"/>
                </a:endParaRPr>
              </a:p>
              <a:p>
                <a:r>
                  <a:rPr lang="en-GB" sz="831" dirty="0">
                    <a:latin typeface="Arial Nova" panose="020B0504020202020204" pitchFamily="34" charset="0"/>
                    <a:cs typeface="Arial" panose="020B0604020202020204" pitchFamily="34" charset="0"/>
                  </a:rPr>
                  <a:t>Lymph node</a:t>
                </a:r>
              </a:p>
            </p:txBody>
          </p:sp>
          <p:pic>
            <p:nvPicPr>
              <p:cNvPr id="3" name="Picture 2" descr="A picture containing table, sitting, green, purple&#10;&#10;Description automatically generated">
                <a:extLst>
                  <a:ext uri="{FF2B5EF4-FFF2-40B4-BE49-F238E27FC236}">
                    <a16:creationId xmlns:a16="http://schemas.microsoft.com/office/drawing/2014/main" id="{DDDE4CD1-7C38-4109-A9B6-6FE06207EF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918384" y="373846"/>
                <a:ext cx="1063385" cy="797538"/>
              </a:xfrm>
              <a:prstGeom prst="rect">
                <a:avLst/>
              </a:prstGeom>
            </p:spPr>
          </p:pic>
          <p:pic>
            <p:nvPicPr>
              <p:cNvPr id="5" name="Picture 4" descr="A picture containing sitting, piece, covered, cake&#10;&#10;Description automatically generated">
                <a:extLst>
                  <a:ext uri="{FF2B5EF4-FFF2-40B4-BE49-F238E27FC236}">
                    <a16:creationId xmlns:a16="http://schemas.microsoft.com/office/drawing/2014/main" id="{27B92FD5-582D-407E-84D8-29D3566F28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61154" y="373846"/>
                <a:ext cx="1063385" cy="797538"/>
              </a:xfrm>
              <a:prstGeom prst="rect">
                <a:avLst/>
              </a:prstGeom>
            </p:spPr>
          </p:pic>
          <p:pic>
            <p:nvPicPr>
              <p:cNvPr id="7" name="Picture 6" descr="A picture containing food, piece, plate, sitting&#10;&#10;Description automatically generated">
                <a:extLst>
                  <a:ext uri="{FF2B5EF4-FFF2-40B4-BE49-F238E27FC236}">
                    <a16:creationId xmlns:a16="http://schemas.microsoft.com/office/drawing/2014/main" id="{F30294B0-1DB8-409D-8E86-7D090AB984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89769" y="373846"/>
                <a:ext cx="1063385" cy="797538"/>
              </a:xfrm>
              <a:prstGeom prst="rect">
                <a:avLst/>
              </a:prstGeom>
            </p:spPr>
          </p:pic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62AE013-3E9A-43DC-9F3A-59AD27794AEE}"/>
                  </a:ext>
                </a:extLst>
              </p:cNvPr>
              <p:cNvSpPr/>
              <p:nvPr/>
            </p:nvSpPr>
            <p:spPr>
              <a:xfrm>
                <a:off x="3971308" y="208722"/>
                <a:ext cx="4361538" cy="972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31">
                  <a:latin typeface="Arial Nova" panose="020B0504020202020204" pitchFamily="34" charset="0"/>
                </a:endParaRPr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3CE998BD-20B5-4481-AFFA-1B59F7C6E271}"/>
                  </a:ext>
                </a:extLst>
              </p:cNvPr>
              <p:cNvGrpSpPr/>
              <p:nvPr/>
            </p:nvGrpSpPr>
            <p:grpSpPr>
              <a:xfrm>
                <a:off x="3961027" y="208722"/>
                <a:ext cx="4363606" cy="245111"/>
                <a:chOff x="288000" y="1008000"/>
                <a:chExt cx="6302987" cy="354049"/>
              </a:xfrm>
            </p:grpSpPr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0C51471D-B1D5-465D-B0D8-40790C544BF4}"/>
                    </a:ext>
                  </a:extLst>
                </p:cNvPr>
                <p:cNvGrpSpPr/>
                <p:nvPr/>
              </p:nvGrpSpPr>
              <p:grpSpPr>
                <a:xfrm>
                  <a:off x="2086195" y="1008000"/>
                  <a:ext cx="4504792" cy="318049"/>
                  <a:chOff x="2086195" y="1008000"/>
                  <a:chExt cx="4504792" cy="318049"/>
                </a:xfrm>
              </p:grpSpPr>
              <p:sp>
                <p:nvSpPr>
                  <p:cNvPr id="20" name="Rectangle 19">
                    <a:extLst>
                      <a:ext uri="{FF2B5EF4-FFF2-40B4-BE49-F238E27FC236}">
                        <a16:creationId xmlns:a16="http://schemas.microsoft.com/office/drawing/2014/main" id="{6FB9C29E-1D66-489C-A6A8-B18A66CC6257}"/>
                      </a:ext>
                    </a:extLst>
                  </p:cNvPr>
                  <p:cNvSpPr/>
                  <p:nvPr/>
                </p:nvSpPr>
                <p:spPr>
                  <a:xfrm>
                    <a:off x="2086195" y="1008000"/>
                    <a:ext cx="625635" cy="31804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831" b="1" dirty="0">
                        <a:solidFill>
                          <a:srgbClr val="222222"/>
                        </a:solidFill>
                        <a:latin typeface="Arial Nova" panose="020B0504020202020204" pitchFamily="34" charset="0"/>
                      </a:rPr>
                      <a:t>H&amp;E</a:t>
                    </a:r>
                    <a:r>
                      <a:rPr lang="en-GB" sz="831" dirty="0">
                        <a:solidFill>
                          <a:srgbClr val="222222"/>
                        </a:solidFill>
                        <a:latin typeface="Arial Nova" panose="020B0504020202020204" pitchFamily="34" charset="0"/>
                      </a:rPr>
                      <a:t> </a:t>
                    </a:r>
                    <a:endParaRPr lang="en-GB" sz="831" dirty="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1" name="Rectangle 20">
                    <a:extLst>
                      <a:ext uri="{FF2B5EF4-FFF2-40B4-BE49-F238E27FC236}">
                        <a16:creationId xmlns:a16="http://schemas.microsoft.com/office/drawing/2014/main" id="{CE97BF70-E2FA-4A32-B8F7-F2C16A5A697D}"/>
                      </a:ext>
                    </a:extLst>
                  </p:cNvPr>
                  <p:cNvSpPr/>
                  <p:nvPr/>
                </p:nvSpPr>
                <p:spPr>
                  <a:xfrm>
                    <a:off x="3816000" y="1008000"/>
                    <a:ext cx="479761" cy="31804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831" b="1" dirty="0">
                        <a:solidFill>
                          <a:srgbClr val="222222"/>
                        </a:solidFill>
                        <a:latin typeface="Arial Nova" panose="020B0504020202020204" pitchFamily="34" charset="0"/>
                      </a:rPr>
                      <a:t>AR</a:t>
                    </a:r>
                    <a:endParaRPr lang="en-GB" sz="831" dirty="0">
                      <a:latin typeface="Arial Nova" panose="020B0504020202020204" pitchFamily="34" charset="0"/>
                    </a:endParaRPr>
                  </a:p>
                </p:txBody>
              </p:sp>
              <p:sp>
                <p:nvSpPr>
                  <p:cNvPr id="22" name="Rectangle 21">
                    <a:extLst>
                      <a:ext uri="{FF2B5EF4-FFF2-40B4-BE49-F238E27FC236}">
                        <a16:creationId xmlns:a16="http://schemas.microsoft.com/office/drawing/2014/main" id="{486E8580-2343-406E-B22D-D9DA6A8B8B1E}"/>
                      </a:ext>
                    </a:extLst>
                  </p:cNvPr>
                  <p:cNvSpPr/>
                  <p:nvPr/>
                </p:nvSpPr>
                <p:spPr>
                  <a:xfrm>
                    <a:off x="5148000" y="1008000"/>
                    <a:ext cx="1442987" cy="31804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831" b="1" dirty="0">
                        <a:latin typeface="Arial Nova" panose="020B0504020202020204" pitchFamily="34" charset="0"/>
                      </a:rPr>
                      <a:t>pan</a:t>
                    </a:r>
                    <a:r>
                      <a:rPr lang="en-GB" sz="831" dirty="0">
                        <a:latin typeface="Arial Nova" panose="020B0504020202020204" pitchFamily="34" charset="0"/>
                      </a:rPr>
                      <a:t>-</a:t>
                    </a:r>
                    <a:r>
                      <a:rPr lang="en-GB" sz="831" b="1" dirty="0">
                        <a:latin typeface="Arial Nova" panose="020B0504020202020204" pitchFamily="34" charset="0"/>
                      </a:rPr>
                      <a:t>Cytokeratin</a:t>
                    </a:r>
                    <a:endParaRPr lang="en-GB" sz="831" dirty="0">
                      <a:latin typeface="Arial Nova" panose="020B0504020202020204" pitchFamily="34" charset="0"/>
                    </a:endParaRPr>
                  </a:p>
                </p:txBody>
              </p:sp>
            </p:grp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5E6BC78E-AADD-4C1E-A403-A27B4AEB6843}"/>
                    </a:ext>
                  </a:extLst>
                </p:cNvPr>
                <p:cNvSpPr/>
                <p:nvPr/>
              </p:nvSpPr>
              <p:spPr>
                <a:xfrm>
                  <a:off x="288000" y="1044000"/>
                  <a:ext cx="375567" cy="318049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r>
                    <a:rPr lang="en-GB" sz="831" b="1" dirty="0">
                      <a:solidFill>
                        <a:srgbClr val="222222"/>
                      </a:solidFill>
                      <a:latin typeface="Arial Nova" panose="020B0504020202020204" pitchFamily="34" charset="0"/>
                    </a:rPr>
                    <a:t>A</a:t>
                  </a:r>
                  <a:endParaRPr lang="en-GB" sz="831" dirty="0">
                    <a:latin typeface="Arial Nova" panose="020B0504020202020204" pitchFamily="34" charset="0"/>
                  </a:endParaRP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D944970A-206C-4305-B111-811F829E744C}"/>
                  </a:ext>
                </a:extLst>
              </p:cNvPr>
              <p:cNvGrpSpPr/>
              <p:nvPr/>
            </p:nvGrpSpPr>
            <p:grpSpPr>
              <a:xfrm>
                <a:off x="5740846" y="1146462"/>
                <a:ext cx="2533843" cy="0"/>
                <a:chOff x="1663200" y="6829406"/>
                <a:chExt cx="3659996" cy="0"/>
              </a:xfrm>
            </p:grpSpPr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A15F70C4-125A-41E3-897A-2FA96174666A}"/>
                    </a:ext>
                  </a:extLst>
                </p:cNvPr>
                <p:cNvCxnSpPr/>
                <p:nvPr/>
              </p:nvCxnSpPr>
              <p:spPr>
                <a:xfrm>
                  <a:off x="1663200" y="6829406"/>
                  <a:ext cx="262800" cy="0"/>
                </a:xfrm>
                <a:prstGeom prst="line">
                  <a:avLst/>
                </a:prstGeom>
                <a:ln w="222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6B5AAE2D-237F-4311-BAA8-F8A1ECEF91FE}"/>
                    </a:ext>
                  </a:extLst>
                </p:cNvPr>
                <p:cNvCxnSpPr/>
                <p:nvPr/>
              </p:nvCxnSpPr>
              <p:spPr>
                <a:xfrm>
                  <a:off x="3363578" y="6829406"/>
                  <a:ext cx="262800" cy="0"/>
                </a:xfrm>
                <a:prstGeom prst="line">
                  <a:avLst/>
                </a:prstGeom>
                <a:ln w="222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AF54ACB0-CB66-4EED-A144-5206D3950603}"/>
                    </a:ext>
                  </a:extLst>
                </p:cNvPr>
                <p:cNvCxnSpPr/>
                <p:nvPr/>
              </p:nvCxnSpPr>
              <p:spPr>
                <a:xfrm>
                  <a:off x="5060396" y="6829406"/>
                  <a:ext cx="262800" cy="0"/>
                </a:xfrm>
                <a:prstGeom prst="line">
                  <a:avLst/>
                </a:prstGeom>
                <a:ln w="2222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BA29C155-40B6-4476-9C79-F19CF983B8C7}"/>
                  </a:ext>
                </a:extLst>
              </p:cNvPr>
              <p:cNvSpPr/>
              <p:nvPr/>
            </p:nvSpPr>
            <p:spPr>
              <a:xfrm>
                <a:off x="4893461" y="383184"/>
                <a:ext cx="3439385" cy="797538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831">
                  <a:latin typeface="Arial Nova" panose="020B0504020202020204" pitchFamily="34" charset="0"/>
                </a:endParaRPr>
              </a:p>
            </p:txBody>
          </p: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1A6E214C-7CCA-48C4-9B43-5DACB1DAED0D}"/>
                </a:ext>
              </a:extLst>
            </p:cNvPr>
            <p:cNvSpPr/>
            <p:nvPr/>
          </p:nvSpPr>
          <p:spPr>
            <a:xfrm>
              <a:off x="3891462" y="556189"/>
              <a:ext cx="200208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i="1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Pten</a:t>
              </a:r>
              <a:r>
                <a:rPr lang="en-GB" sz="1200" i="1" baseline="30000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fl</a:t>
              </a:r>
              <a:r>
                <a:rPr lang="en-GB" sz="1200" i="1" baseline="30000" dirty="0">
                  <a:solidFill>
                    <a:prstClr val="black"/>
                  </a:solidFill>
                  <a:latin typeface="Arial Nova" panose="020B0504020202020204" pitchFamily="34" charset="0"/>
                </a:rPr>
                <a:t>/</a:t>
              </a:r>
              <a:r>
                <a:rPr lang="en-GB" sz="1200" i="1" baseline="30000" dirty="0" err="1">
                  <a:solidFill>
                    <a:prstClr val="black"/>
                  </a:solidFill>
                  <a:latin typeface="Arial Nova" panose="020B0504020202020204" pitchFamily="34" charset="0"/>
                </a:rPr>
                <a:t>fl</a:t>
              </a:r>
              <a:r>
                <a:rPr lang="en-GB" sz="1200" i="1" dirty="0">
                  <a:solidFill>
                    <a:prstClr val="black"/>
                  </a:solidFill>
                  <a:latin typeface="Arial Nova" panose="020B0504020202020204" pitchFamily="34" charset="0"/>
                </a:rPr>
                <a:t> Kras</a:t>
              </a:r>
              <a:r>
                <a:rPr lang="en-GB" sz="1200" i="1" baseline="30000" dirty="0">
                  <a:latin typeface="Arial Nova" panose="020B0504020202020204" pitchFamily="34" charset="0"/>
                </a:rPr>
                <a:t>G12V</a:t>
              </a:r>
              <a:r>
                <a:rPr lang="en-GB" sz="1200" i="1" baseline="30000" dirty="0">
                  <a:solidFill>
                    <a:prstClr val="black"/>
                  </a:solidFill>
                  <a:latin typeface="Arial Nova" panose="020B0504020202020204" pitchFamily="34" charset="0"/>
                </a:rPr>
                <a:t> </a:t>
              </a:r>
              <a:r>
                <a:rPr lang="en-GB" sz="1200" i="1" dirty="0">
                  <a:solidFill>
                    <a:prstClr val="black"/>
                  </a:solidFill>
                  <a:latin typeface="Arial Nova" panose="020B0504020202020204" pitchFamily="34" charset="0"/>
                </a:rPr>
                <a:t>PLXNB1</a:t>
              </a:r>
              <a:r>
                <a:rPr lang="en-GB" sz="1200" i="1" baseline="30000" dirty="0">
                  <a:solidFill>
                    <a:prstClr val="black"/>
                  </a:solidFill>
                  <a:latin typeface="Arial Nova" panose="020B0504020202020204" pitchFamily="34" charset="0"/>
                </a:rPr>
                <a:t>WT</a:t>
              </a:r>
              <a:endParaRPr lang="en-GB" sz="1200" dirty="0">
                <a:latin typeface="Arial Nova" panose="020B0504020202020204" pitchFamily="34" charset="0"/>
              </a:endParaRP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879B3966-6F38-49B7-92AD-3164D21C1AF4}"/>
              </a:ext>
            </a:extLst>
          </p:cNvPr>
          <p:cNvSpPr txBox="1"/>
          <p:nvPr/>
        </p:nvSpPr>
        <p:spPr>
          <a:xfrm>
            <a:off x="3060213" y="4110216"/>
            <a:ext cx="6096000" cy="11417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 S5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etastatic deposit in </a:t>
            </a:r>
            <a:r>
              <a:rPr lang="en-GB" sz="1200" b="1" i="1" kern="1200" dirty="0" err="1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ten</a:t>
            </a:r>
            <a:r>
              <a:rPr lang="en-GB" sz="1200" b="1" i="1" kern="1200" baseline="30000" dirty="0" err="1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l</a:t>
            </a:r>
            <a:r>
              <a:rPr lang="en-GB" sz="1200" b="1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/fl</a:t>
            </a:r>
            <a:r>
              <a:rPr lang="en-GB" sz="1200" b="1" i="1" kern="1200" dirty="0"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Kras</a:t>
            </a:r>
            <a:r>
              <a:rPr lang="en-GB" sz="1200" b="1" i="1" kern="1200" baseline="30000" dirty="0"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12V</a:t>
            </a:r>
            <a:r>
              <a:rPr lang="en-GB" sz="1200" b="1" i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LXNB1</a:t>
            </a:r>
            <a:r>
              <a:rPr lang="en-GB" sz="1200" b="1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T</a:t>
            </a:r>
            <a:r>
              <a:rPr lang="en-GB" sz="1200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ouse stained for H&amp;E, androgen receptor (AR) and pan-cytokeratin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Metastatic deposits were observed in a single </a:t>
            </a:r>
            <a:r>
              <a:rPr lang="en-GB" sz="1200" i="1" kern="1200" dirty="0" err="1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ten</a:t>
            </a:r>
            <a:r>
              <a:rPr lang="en-GB" sz="1200" i="1" kern="1200" baseline="30000" dirty="0" err="1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l</a:t>
            </a:r>
            <a:r>
              <a:rPr lang="en-GB" sz="1200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/</a:t>
            </a:r>
            <a:r>
              <a:rPr lang="en-GB" sz="1200" i="1" kern="1200" baseline="30000" dirty="0" err="1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l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Kras</a:t>
            </a:r>
            <a:r>
              <a:rPr lang="en-GB" sz="1200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V12 </a:t>
            </a:r>
            <a:r>
              <a:rPr lang="en-GB" sz="1200" i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LXNB1</a:t>
            </a:r>
            <a:r>
              <a:rPr lang="en-GB" sz="1200" i="1" kern="1200" baseline="300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T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hort animal, met1 (#110, 178 days old, 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. Sections were stained for H&amp;E (left image), AR (middle image) and pan-cytokeratin (right image). Scale bars are 200</a:t>
            </a:r>
            <a:r>
              <a:rPr lang="el-GR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μ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Arial Nova" panose="020B05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.</a:t>
            </a:r>
            <a:endParaRPr lang="en-GB" sz="1200" dirty="0">
              <a:effectLst/>
              <a:latin typeface="Arial Nova" panose="020B05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1759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1-04T17:06:17Z</dcterms:created>
  <dcterms:modified xsi:type="dcterms:W3CDTF">2023-01-04T17:07:12Z</dcterms:modified>
</cp:coreProperties>
</file>